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196" autoAdjust="0"/>
    <p:restoredTop sz="94660"/>
  </p:normalViewPr>
  <p:slideViewPr>
    <p:cSldViewPr snapToGrid="0">
      <p:cViewPr varScale="1">
        <p:scale>
          <a:sx n="76" d="100"/>
          <a:sy n="76" d="100"/>
        </p:scale>
        <p:origin x="31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chuster Gadi" userId="8014ead3-d102-41a2-8e53-d5bceadeebe2" providerId="ADAL" clId="{E7470423-E9D2-42EB-94C4-F83D031DF650}"/>
    <pc:docChg chg="custSel modSld">
      <pc:chgData name="Schuster Gadi" userId="8014ead3-d102-41a2-8e53-d5bceadeebe2" providerId="ADAL" clId="{E7470423-E9D2-42EB-94C4-F83D031DF650}" dt="2024-05-29T08:41:43.930" v="4" actId="1076"/>
      <pc:docMkLst>
        <pc:docMk/>
      </pc:docMkLst>
      <pc:sldChg chg="modSp mod">
        <pc:chgData name="Schuster Gadi" userId="8014ead3-d102-41a2-8e53-d5bceadeebe2" providerId="ADAL" clId="{E7470423-E9D2-42EB-94C4-F83D031DF650}" dt="2024-05-29T08:41:43.930" v="4" actId="1076"/>
        <pc:sldMkLst>
          <pc:docMk/>
          <pc:sldMk cId="2034325348" sldId="1341"/>
        </pc:sldMkLst>
        <pc:spChg chg="mod">
          <ac:chgData name="Schuster Gadi" userId="8014ead3-d102-41a2-8e53-d5bceadeebe2" providerId="ADAL" clId="{E7470423-E9D2-42EB-94C4-F83D031DF650}" dt="2024-05-29T08:41:43.930" v="4" actId="1076"/>
          <ac:spMkLst>
            <pc:docMk/>
            <pc:sldMk cId="2034325348" sldId="1341"/>
            <ac:spMk id="18" creationId="{351D47F2-9952-490B-8F22-8176E75E4E18}"/>
          </ac:spMkLst>
        </pc:spChg>
        <pc:spChg chg="mod">
          <ac:chgData name="Schuster Gadi" userId="8014ead3-d102-41a2-8e53-d5bceadeebe2" providerId="ADAL" clId="{E7470423-E9D2-42EB-94C4-F83D031DF650}" dt="2024-05-28T06:49:29.122" v="1" actId="313"/>
          <ac:spMkLst>
            <pc:docMk/>
            <pc:sldMk cId="2034325348" sldId="1341"/>
            <ac:spMk id="55" creationId="{18D0CA16-79D7-50D2-ACA1-12655DCE9869}"/>
          </ac:spMkLst>
        </pc:spChg>
        <pc:spChg chg="mod">
          <ac:chgData name="Schuster Gadi" userId="8014ead3-d102-41a2-8e53-d5bceadeebe2" providerId="ADAL" clId="{E7470423-E9D2-42EB-94C4-F83D031DF650}" dt="2024-05-28T06:49:33.174" v="3" actId="313"/>
          <ac:spMkLst>
            <pc:docMk/>
            <pc:sldMk cId="2034325348" sldId="1341"/>
            <ac:spMk id="61" creationId="{96332946-C41D-02AC-6D37-BE3997BC9C4A}"/>
          </ac:spMkLst>
        </pc:spChg>
      </pc:sldChg>
    </pc:docChg>
  </pc:docChgLst>
  <pc:docChgLst>
    <pc:chgData name="Guy Levin" userId="796a6ee1-938f-4754-82f4-44af232fdd3d" providerId="ADAL" clId="{71A9A29E-8629-4A1B-A2EC-F9D9E41292AC}"/>
    <pc:docChg chg="undo custSel modSld">
      <pc:chgData name="Guy Levin" userId="796a6ee1-938f-4754-82f4-44af232fdd3d" providerId="ADAL" clId="{71A9A29E-8629-4A1B-A2EC-F9D9E41292AC}" dt="2024-08-27T19:13:45.463" v="16" actId="20577"/>
      <pc:docMkLst>
        <pc:docMk/>
      </pc:docMkLst>
      <pc:sldChg chg="addSp delSp modSp">
        <pc:chgData name="Guy Levin" userId="796a6ee1-938f-4754-82f4-44af232fdd3d" providerId="ADAL" clId="{71A9A29E-8629-4A1B-A2EC-F9D9E41292AC}" dt="2024-08-26T09:09:15.358" v="14" actId="1076"/>
        <pc:sldMkLst>
          <pc:docMk/>
          <pc:sldMk cId="4102523903" sldId="290"/>
        </pc:sldMkLst>
        <pc:spChg chg="del">
          <ac:chgData name="Guy Levin" userId="796a6ee1-938f-4754-82f4-44af232fdd3d" providerId="ADAL" clId="{71A9A29E-8629-4A1B-A2EC-F9D9E41292AC}" dt="2024-08-26T09:08:59.611" v="12" actId="478"/>
          <ac:spMkLst>
            <pc:docMk/>
            <pc:sldMk cId="4102523903" sldId="290"/>
            <ac:spMk id="21" creationId="{058936D1-6581-426F-8746-9048BC216317}"/>
          </ac:spMkLst>
        </pc:spChg>
        <pc:spChg chg="add mod">
          <ac:chgData name="Guy Levin" userId="796a6ee1-938f-4754-82f4-44af232fdd3d" providerId="ADAL" clId="{71A9A29E-8629-4A1B-A2EC-F9D9E41292AC}" dt="2024-08-26T09:09:15.358" v="14" actId="1076"/>
          <ac:spMkLst>
            <pc:docMk/>
            <pc:sldMk cId="4102523903" sldId="290"/>
            <ac:spMk id="28" creationId="{058936D1-6581-426F-8746-9048BC216317}"/>
          </ac:spMkLst>
        </pc:spChg>
      </pc:sldChg>
      <pc:sldChg chg="addSp delSp modSp">
        <pc:chgData name="Guy Levin" userId="796a6ee1-938f-4754-82f4-44af232fdd3d" providerId="ADAL" clId="{71A9A29E-8629-4A1B-A2EC-F9D9E41292AC}" dt="2024-08-26T09:08:43.047" v="8" actId="1076"/>
        <pc:sldMkLst>
          <pc:docMk/>
          <pc:sldMk cId="1432036717" sldId="299"/>
        </pc:sldMkLst>
        <pc:spChg chg="del">
          <ac:chgData name="Guy Levin" userId="796a6ee1-938f-4754-82f4-44af232fdd3d" providerId="ADAL" clId="{71A9A29E-8629-4A1B-A2EC-F9D9E41292AC}" dt="2024-08-26T09:08:27.524" v="4" actId="478"/>
          <ac:spMkLst>
            <pc:docMk/>
            <pc:sldMk cId="1432036717" sldId="299"/>
            <ac:spMk id="3" creationId="{FAEEBF45-B1CE-41D6-8ED1-AE1699FC69DD}"/>
          </ac:spMkLst>
        </pc:spChg>
        <pc:spChg chg="add mod">
          <ac:chgData name="Guy Levin" userId="796a6ee1-938f-4754-82f4-44af232fdd3d" providerId="ADAL" clId="{71A9A29E-8629-4A1B-A2EC-F9D9E41292AC}" dt="2024-08-26T09:08:43.047" v="8" actId="1076"/>
          <ac:spMkLst>
            <pc:docMk/>
            <pc:sldMk cId="1432036717" sldId="299"/>
            <ac:spMk id="26" creationId="{C11AA62B-374B-4F49-ADFB-BCD75BCA9C29}"/>
          </ac:spMkLst>
        </pc:spChg>
        <pc:picChg chg="mod">
          <ac:chgData name="Guy Levin" userId="796a6ee1-938f-4754-82f4-44af232fdd3d" providerId="ADAL" clId="{71A9A29E-8629-4A1B-A2EC-F9D9E41292AC}" dt="2024-08-26T09:08:39.428" v="7" actId="1076"/>
          <ac:picMkLst>
            <pc:docMk/>
            <pc:sldMk cId="1432036717" sldId="299"/>
            <ac:picMk id="4" creationId="{FFC30E95-BD35-4623-996C-6B14A747A8C0}"/>
          </ac:picMkLst>
        </pc:picChg>
      </pc:sldChg>
      <pc:sldChg chg="addSp delSp modSp">
        <pc:chgData name="Guy Levin" userId="796a6ee1-938f-4754-82f4-44af232fdd3d" providerId="ADAL" clId="{71A9A29E-8629-4A1B-A2EC-F9D9E41292AC}" dt="2024-08-26T09:08:56.534" v="11" actId="1076"/>
        <pc:sldMkLst>
          <pc:docMk/>
          <pc:sldMk cId="2828842376" sldId="305"/>
        </pc:sldMkLst>
        <pc:spChg chg="del">
          <ac:chgData name="Guy Levin" userId="796a6ee1-938f-4754-82f4-44af232fdd3d" providerId="ADAL" clId="{71A9A29E-8629-4A1B-A2EC-F9D9E41292AC}" dt="2024-08-26T09:08:49.131" v="9" actId="478"/>
          <ac:spMkLst>
            <pc:docMk/>
            <pc:sldMk cId="2828842376" sldId="305"/>
            <ac:spMk id="42" creationId="{5D37DAEB-9531-4C3F-AB3B-0D625453EAAA}"/>
          </ac:spMkLst>
        </pc:spChg>
        <pc:spChg chg="add mod">
          <ac:chgData name="Guy Levin" userId="796a6ee1-938f-4754-82f4-44af232fdd3d" providerId="ADAL" clId="{71A9A29E-8629-4A1B-A2EC-F9D9E41292AC}" dt="2024-08-26T09:08:56.534" v="11" actId="1076"/>
          <ac:spMkLst>
            <pc:docMk/>
            <pc:sldMk cId="2828842376" sldId="305"/>
            <ac:spMk id="46" creationId="{5D37DAEB-9531-4C3F-AB3B-0D625453EAAA}"/>
          </ac:spMkLst>
        </pc:spChg>
      </pc:sldChg>
      <pc:sldChg chg="addSp delSp modSp">
        <pc:chgData name="Guy Levin" userId="796a6ee1-938f-4754-82f4-44af232fdd3d" providerId="ADAL" clId="{71A9A29E-8629-4A1B-A2EC-F9D9E41292AC}" dt="2024-08-27T19:13:45.463" v="16" actId="20577"/>
        <pc:sldMkLst>
          <pc:docMk/>
          <pc:sldMk cId="2034325348" sldId="1341"/>
        </pc:sldMkLst>
        <pc:spChg chg="del">
          <ac:chgData name="Guy Levin" userId="796a6ee1-938f-4754-82f4-44af232fdd3d" providerId="ADAL" clId="{71A9A29E-8629-4A1B-A2EC-F9D9E41292AC}" dt="2024-08-26T09:08:20.284" v="2" actId="478"/>
          <ac:spMkLst>
            <pc:docMk/>
            <pc:sldMk cId="2034325348" sldId="1341"/>
            <ac:spMk id="18" creationId="{351D47F2-9952-490B-8F22-8176E75E4E18}"/>
          </ac:spMkLst>
        </pc:spChg>
        <pc:spChg chg="add mod">
          <ac:chgData name="Guy Levin" userId="796a6ee1-938f-4754-82f4-44af232fdd3d" providerId="ADAL" clId="{71A9A29E-8629-4A1B-A2EC-F9D9E41292AC}" dt="2024-08-26T09:08:23.286" v="3" actId="1076"/>
          <ac:spMkLst>
            <pc:docMk/>
            <pc:sldMk cId="2034325348" sldId="1341"/>
            <ac:spMk id="31" creationId="{351D47F2-9952-490B-8F22-8176E75E4E18}"/>
          </ac:spMkLst>
        </pc:spChg>
        <pc:spChg chg="mod">
          <ac:chgData name="Guy Levin" userId="796a6ee1-938f-4754-82f4-44af232fdd3d" providerId="ADAL" clId="{71A9A29E-8629-4A1B-A2EC-F9D9E41292AC}" dt="2024-08-27T19:13:45.463" v="16" actId="20577"/>
          <ac:spMkLst>
            <pc:docMk/>
            <pc:sldMk cId="2034325348" sldId="1341"/>
            <ac:spMk id="32" creationId="{4E08334C-5551-4F10-B8D2-414AF554C9CF}"/>
          </ac:spMkLst>
        </pc:spChg>
        <pc:spChg chg="mod">
          <ac:chgData name="Guy Levin" userId="796a6ee1-938f-4754-82f4-44af232fdd3d" providerId="ADAL" clId="{71A9A29E-8629-4A1B-A2EC-F9D9E41292AC}" dt="2024-08-27T19:13:42.712" v="15" actId="20577"/>
          <ac:spMkLst>
            <pc:docMk/>
            <pc:sldMk cId="2034325348" sldId="1341"/>
            <ac:spMk id="39" creationId="{442F91BD-7E58-4516-A0E5-B1741BB1CD70}"/>
          </ac:spMkLst>
        </pc:spChg>
      </pc:sldChg>
    </pc:docChg>
  </pc:docChgLst>
  <pc:docChgLst>
    <pc:chgData name="Guy Levin" userId="796a6ee1-938f-4754-82f4-44af232fdd3d" providerId="ADAL" clId="{65675048-CCC5-4663-A5ED-1EE0BAA0D74C}"/>
    <pc:docChg chg="undo custSel modSld">
      <pc:chgData name="Guy Levin" userId="796a6ee1-938f-4754-82f4-44af232fdd3d" providerId="ADAL" clId="{65675048-CCC5-4663-A5ED-1EE0BAA0D74C}" dt="2024-06-10T12:25:06.540" v="24" actId="478"/>
      <pc:docMkLst>
        <pc:docMk/>
      </pc:docMkLst>
      <pc:sldChg chg="delSp modSp">
        <pc:chgData name="Guy Levin" userId="796a6ee1-938f-4754-82f4-44af232fdd3d" providerId="ADAL" clId="{65675048-CCC5-4663-A5ED-1EE0BAA0D74C}" dt="2024-06-10T12:25:06.540" v="24" actId="478"/>
        <pc:sldMkLst>
          <pc:docMk/>
          <pc:sldMk cId="1432036717" sldId="299"/>
        </pc:sldMkLst>
        <pc:spChg chg="mod">
          <ac:chgData name="Guy Levin" userId="796a6ee1-938f-4754-82f4-44af232fdd3d" providerId="ADAL" clId="{65675048-CCC5-4663-A5ED-1EE0BAA0D74C}" dt="2024-06-10T12:24:12.117" v="23" actId="20577"/>
          <ac:spMkLst>
            <pc:docMk/>
            <pc:sldMk cId="1432036717" sldId="299"/>
            <ac:spMk id="3" creationId="{FAEEBF45-B1CE-41D6-8ED1-AE1699FC69DD}"/>
          </ac:spMkLst>
        </pc:spChg>
        <pc:spChg chg="del">
          <ac:chgData name="Guy Levin" userId="796a6ee1-938f-4754-82f4-44af232fdd3d" providerId="ADAL" clId="{65675048-CCC5-4663-A5ED-1EE0BAA0D74C}" dt="2024-06-10T12:25:06.540" v="24" actId="478"/>
          <ac:spMkLst>
            <pc:docMk/>
            <pc:sldMk cId="1432036717" sldId="299"/>
            <ac:spMk id="26" creationId="{2F0EF0D1-ABFB-119A-65D4-C9554E040AEE}"/>
          </ac:spMkLst>
        </pc:spChg>
      </pc:sldChg>
      <pc:sldChg chg="addSp delSp modSp">
        <pc:chgData name="Guy Levin" userId="796a6ee1-938f-4754-82f4-44af232fdd3d" providerId="ADAL" clId="{65675048-CCC5-4663-A5ED-1EE0BAA0D74C}" dt="2024-06-10T12:21:54.669" v="17" actId="1076"/>
        <pc:sldMkLst>
          <pc:docMk/>
          <pc:sldMk cId="2034325348" sldId="1341"/>
        </pc:sldMkLst>
        <pc:spChg chg="del">
          <ac:chgData name="Guy Levin" userId="796a6ee1-938f-4754-82f4-44af232fdd3d" providerId="ADAL" clId="{65675048-CCC5-4663-A5ED-1EE0BAA0D74C}" dt="2024-05-28T08:25:06.213" v="5" actId="478"/>
          <ac:spMkLst>
            <pc:docMk/>
            <pc:sldMk cId="2034325348" sldId="1341"/>
            <ac:spMk id="2" creationId="{55E46FE8-192C-4312-9422-40CB7E225B57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3" creationId="{165C13E4-BA30-EEEC-9915-48143670ED7A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6" creationId="{33CB28F7-7461-3EF5-B9B7-3105B0B2206D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7" creationId="{CC2CA53A-FD0B-4E93-A8B1-720ED9487CEF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8" creationId="{71718261-F870-405A-818B-40CA1C0E0621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9" creationId="{F53BD0DB-512E-45F4-BB54-B16EAC518175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0" creationId="{92998ABC-1CA5-4925-B230-FA541E090F4D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1" creationId="{A87B4BDE-161F-4D79-9B7F-E6C5015FE53C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2" creationId="{AF079CAE-64DD-20D7-62FC-A8309E8F4D39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13" creationId="{7DE3C3B9-D187-A150-9245-94703824B1DD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14" creationId="{45215AE7-9B66-D777-8C8C-7FBC30B43652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8" creationId="{351D47F2-9952-490B-8F22-8176E75E4E18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9" creationId="{3EAF3056-30CA-4278-A4D3-F03EBD4B6945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27" creationId="{CFBCC9AD-A44C-4320-A224-5A980C2F45AE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32" creationId="{4E08334C-5551-4F10-B8D2-414AF554C9CF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39" creationId="{442F91BD-7E58-4516-A0E5-B1741BB1CD70}"/>
          </ac:spMkLst>
        </pc:spChg>
        <pc:spChg chg="add del mod">
          <ac:chgData name="Guy Levin" userId="796a6ee1-938f-4754-82f4-44af232fdd3d" providerId="ADAL" clId="{65675048-CCC5-4663-A5ED-1EE0BAA0D74C}" dt="2024-06-10T12:21:45.788" v="16" actId="478"/>
          <ac:spMkLst>
            <pc:docMk/>
            <pc:sldMk cId="2034325348" sldId="1341"/>
            <ac:spMk id="42" creationId="{F54F0CF5-7E95-9CF3-D830-D6C8FE1DDA12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3" creationId="{C48E2339-A1DD-771A-80C7-9940FC2FABB5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4" creationId="{90CF2406-3037-9C9C-AF1E-DE7FA3E90D61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5" creationId="{D36347BB-CBDC-25D6-7DF2-50711EC7F98E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6" creationId="{08DD1927-D977-D767-A09F-140F79C784B0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7" creationId="{CF8A812E-FB7B-D64B-A87E-71041EBFC7E8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8" creationId="{DA840B66-9B47-8EA6-9183-B6D11B2648B3}"/>
          </ac:spMkLst>
        </pc:spChg>
        <pc:spChg chg="del">
          <ac:chgData name="Guy Levin" userId="796a6ee1-938f-4754-82f4-44af232fdd3d" providerId="ADAL" clId="{65675048-CCC5-4663-A5ED-1EE0BAA0D74C}" dt="2024-05-28T08:24:56.670" v="3" actId="478"/>
          <ac:spMkLst>
            <pc:docMk/>
            <pc:sldMk cId="2034325348" sldId="1341"/>
            <ac:spMk id="49" creationId="{E7741978-D8C9-2318-5BF5-1DBF5E6B8D0A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0" creationId="{61E5856D-B67D-8DE6-EBDC-E066CE75D44B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1" creationId="{AB10EBB5-A46F-7696-9F1A-887F9817DBA5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2" creationId="{56642583-FDEC-457F-5062-C68A665985C6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3" creationId="{3C8F68FA-E444-0ECD-0207-B9E3B00412A4}"/>
          </ac:spMkLst>
        </pc:spChg>
        <pc:spChg chg="del">
          <ac:chgData name="Guy Levin" userId="796a6ee1-938f-4754-82f4-44af232fdd3d" providerId="ADAL" clId="{65675048-CCC5-4663-A5ED-1EE0BAA0D74C}" dt="2024-05-28T08:24:56.670" v="3" actId="478"/>
          <ac:spMkLst>
            <pc:docMk/>
            <pc:sldMk cId="2034325348" sldId="1341"/>
            <ac:spMk id="54" creationId="{2286ECCD-B173-3DFA-4B20-67505863486A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55" creationId="{18D0CA16-79D7-50D2-ACA1-12655DCE9869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61" creationId="{96332946-C41D-02AC-6D37-BE3997BC9C4A}"/>
          </ac:spMkLst>
        </pc:spChg>
        <pc:spChg chg="del">
          <ac:chgData name="Guy Levin" userId="796a6ee1-938f-4754-82f4-44af232fdd3d" providerId="ADAL" clId="{65675048-CCC5-4663-A5ED-1EE0BAA0D74C}" dt="2024-05-28T08:25:09.671" v="6" actId="478"/>
          <ac:spMkLst>
            <pc:docMk/>
            <pc:sldMk cId="2034325348" sldId="1341"/>
            <ac:spMk id="65" creationId="{18CA557C-D93A-5EE2-A05D-7D7565907F58}"/>
          </ac:spMkLst>
        </pc:spChg>
        <pc:grpChg chg="del">
          <ac:chgData name="Guy Levin" userId="796a6ee1-938f-4754-82f4-44af232fdd3d" providerId="ADAL" clId="{65675048-CCC5-4663-A5ED-1EE0BAA0D74C}" dt="2024-05-28T08:25:02.940" v="4" actId="478"/>
          <ac:grpSpMkLst>
            <pc:docMk/>
            <pc:sldMk cId="2034325348" sldId="1341"/>
            <ac:grpSpMk id="29" creationId="{CC4D41E3-3319-4983-A208-66D0FC1AB5AB}"/>
          </ac:grpSpMkLst>
        </pc:grpChg>
        <pc:graphicFrameChg chg="mod">
          <ac:chgData name="Guy Levin" userId="796a6ee1-938f-4754-82f4-44af232fdd3d" providerId="ADAL" clId="{65675048-CCC5-4663-A5ED-1EE0BAA0D74C}" dt="2024-06-10T12:21:54.669" v="17" actId="1076"/>
          <ac:graphicFrameMkLst>
            <pc:docMk/>
            <pc:sldMk cId="2034325348" sldId="1341"/>
            <ac:graphicFrameMk id="24" creationId="{7A4B8413-4EA1-419B-B015-CE81E9A436DF}"/>
          </ac:graphicFrameMkLst>
        </pc:graphicFrameChg>
        <pc:graphicFrameChg chg="mod">
          <ac:chgData name="Guy Levin" userId="796a6ee1-938f-4754-82f4-44af232fdd3d" providerId="ADAL" clId="{65675048-CCC5-4663-A5ED-1EE0BAA0D74C}" dt="2024-06-10T12:21:54.669" v="17" actId="1076"/>
          <ac:graphicFrameMkLst>
            <pc:docMk/>
            <pc:sldMk cId="2034325348" sldId="1341"/>
            <ac:graphicFrameMk id="25" creationId="{D527C7FC-D266-464D-AC00-9E823F3D3132}"/>
          </ac:graphicFrameMkLst>
        </pc:graphicFrameChg>
        <pc:graphicFrameChg chg="del mod">
          <ac:chgData name="Guy Levin" userId="796a6ee1-938f-4754-82f4-44af232fdd3d" providerId="ADAL" clId="{65675048-CCC5-4663-A5ED-1EE0BAA0D74C}" dt="2024-05-28T08:25:02.940" v="4" actId="478"/>
          <ac:graphicFrameMkLst>
            <pc:docMk/>
            <pc:sldMk cId="2034325348" sldId="1341"/>
            <ac:graphicFrameMk id="26" creationId="{EDFB0453-9FA4-4A12-AAC9-712B52B6094D}"/>
          </ac:graphicFrameMkLst>
        </pc:graphicFrameChg>
        <pc:graphicFrameChg chg="del">
          <ac:chgData name="Guy Levin" userId="796a6ee1-938f-4754-82f4-44af232fdd3d" providerId="ADAL" clId="{65675048-CCC5-4663-A5ED-1EE0BAA0D74C}" dt="2024-05-28T08:24:54.321" v="2" actId="478"/>
          <ac:graphicFrameMkLst>
            <pc:docMk/>
            <pc:sldMk cId="2034325348" sldId="1341"/>
            <ac:graphicFrameMk id="33" creationId="{FC92DF1C-A388-4E18-A40A-24379A5F7132}"/>
          </ac:graphicFrameMkLst>
        </pc:graphicFrameChg>
        <pc:graphicFrameChg chg="add del mod">
          <ac:chgData name="Guy Levin" userId="796a6ee1-938f-4754-82f4-44af232fdd3d" providerId="ADAL" clId="{65675048-CCC5-4663-A5ED-1EE0BAA0D74C}" dt="2024-06-10T12:21:41.736" v="14" actId="478"/>
          <ac:graphicFrameMkLst>
            <pc:docMk/>
            <pc:sldMk cId="2034325348" sldId="1341"/>
            <ac:graphicFrameMk id="56" creationId="{D15D6FC2-6851-4B2E-847B-99E6A4252B51}"/>
          </ac:graphicFrameMkLst>
        </pc:graphicFrameChg>
        <pc:picChg chg="mod">
          <ac:chgData name="Guy Levin" userId="796a6ee1-938f-4754-82f4-44af232fdd3d" providerId="ADAL" clId="{65675048-CCC5-4663-A5ED-1EE0BAA0D74C}" dt="2024-06-10T12:21:54.669" v="17" actId="1076"/>
          <ac:picMkLst>
            <pc:docMk/>
            <pc:sldMk cId="2034325348" sldId="1341"/>
            <ac:picMk id="4" creationId="{35AB84AC-F5FF-40C7-A759-6AC20D7BDB50}"/>
          </ac:picMkLst>
        </pc:picChg>
        <pc:picChg chg="mod">
          <ac:chgData name="Guy Levin" userId="796a6ee1-938f-4754-82f4-44af232fdd3d" providerId="ADAL" clId="{65675048-CCC5-4663-A5ED-1EE0BAA0D74C}" dt="2024-06-10T12:21:54.669" v="17" actId="1076"/>
          <ac:picMkLst>
            <pc:docMk/>
            <pc:sldMk cId="2034325348" sldId="1341"/>
            <ac:picMk id="5" creationId="{A278E044-1B9A-473A-83C4-1E829CFFA60F}"/>
          </ac:picMkLst>
        </pc:pic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57" creationId="{928D54EA-EE16-194A-C19F-74BE30C7F4FC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59" creationId="{5EB2AD94-AF6F-C711-1083-456F64ED4610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0" creationId="{BB9922AD-D9C8-62A2-B090-E7A09F1482A3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2" creationId="{808387B6-212A-3E56-0137-87339CE337FB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3" creationId="{871009F6-5DD7-242F-8F13-7C84975816DC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4" creationId="{CB172AF9-73CE-263C-FBEC-C06E401178A2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709135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123372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151846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312786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620784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164341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5855481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2550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599523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891811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155418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628209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FC30E95-BD35-4623-996C-6B14A747A8C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59" t="14418" r="21599" b="23256"/>
          <a:stretch/>
        </p:blipFill>
        <p:spPr>
          <a:xfrm>
            <a:off x="3495968" y="4519654"/>
            <a:ext cx="2845462" cy="128814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1A24A51-6F6F-4A00-A23D-0EAD49F21A2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47" t="14115" r="21774" b="23411"/>
          <a:stretch/>
        </p:blipFill>
        <p:spPr>
          <a:xfrm>
            <a:off x="502325" y="4523824"/>
            <a:ext cx="2866399" cy="130511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0A44A1C-130F-44B7-BC9A-C0E55345462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46" t="13799" r="21860" b="23101"/>
          <a:stretch/>
        </p:blipFill>
        <p:spPr>
          <a:xfrm>
            <a:off x="3495970" y="6354180"/>
            <a:ext cx="2880222" cy="132607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B6C5DC5-3E2F-40D8-9547-6215FA815AA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33" t="13567" r="21860" b="23101"/>
          <a:stretch/>
        </p:blipFill>
        <p:spPr>
          <a:xfrm>
            <a:off x="502325" y="6354180"/>
            <a:ext cx="2866400" cy="132607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08DE026-B790-4879-AE52-5CD3EBD5A6C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24" t="14133" r="21701" b="23200"/>
          <a:stretch/>
        </p:blipFill>
        <p:spPr>
          <a:xfrm>
            <a:off x="3498336" y="949871"/>
            <a:ext cx="2877187" cy="130907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00BA83E-ED04-40D2-8D0B-8B3DAD997EA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75" t="13600" r="21475" b="23200"/>
          <a:stretch/>
        </p:blipFill>
        <p:spPr>
          <a:xfrm>
            <a:off x="500257" y="944952"/>
            <a:ext cx="2866399" cy="131399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AAB1E2F1-B3BF-4E34-9C2C-238097C20F8E}"/>
              </a:ext>
            </a:extLst>
          </p:cNvPr>
          <p:cNvSpPr txBox="1"/>
          <p:nvPr/>
        </p:nvSpPr>
        <p:spPr>
          <a:xfrm>
            <a:off x="2523234" y="625804"/>
            <a:ext cx="2203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0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 photons m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99DFA582-B066-45CB-9F99-7632FE535D2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046" t="13644" r="21686" b="23101"/>
          <a:stretch/>
        </p:blipFill>
        <p:spPr>
          <a:xfrm>
            <a:off x="502325" y="2753095"/>
            <a:ext cx="2866399" cy="131996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4D63CB2-078F-49B7-8137-2FB047AAB94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046" t="13489" r="21948" b="23721"/>
          <a:stretch/>
        </p:blipFill>
        <p:spPr>
          <a:xfrm>
            <a:off x="3498337" y="2753094"/>
            <a:ext cx="2877855" cy="1319967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851FC1F7-88BC-4099-AEC0-8C0353E4DDB7}"/>
              </a:ext>
            </a:extLst>
          </p:cNvPr>
          <p:cNvSpPr/>
          <p:nvPr/>
        </p:nvSpPr>
        <p:spPr>
          <a:xfrm>
            <a:off x="4263689" y="250020"/>
            <a:ext cx="15522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chemeClr val="accent2"/>
                </a:solidFill>
              </a:rPr>
              <a:t>HL-</a:t>
            </a:r>
            <a:r>
              <a:rPr lang="en-US" dirty="0"/>
              <a:t>grown cells</a:t>
            </a:r>
            <a:endParaRPr lang="en-IL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71F4A0F-99C5-4984-9A46-271EADE6F6F0}"/>
              </a:ext>
            </a:extLst>
          </p:cNvPr>
          <p:cNvSpPr txBox="1"/>
          <p:nvPr/>
        </p:nvSpPr>
        <p:spPr>
          <a:xfrm>
            <a:off x="2523234" y="2457829"/>
            <a:ext cx="2203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0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 photons m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947DD91-981A-44C8-9315-E3C1F1EB996F}"/>
              </a:ext>
            </a:extLst>
          </p:cNvPr>
          <p:cNvSpPr txBox="1"/>
          <p:nvPr/>
        </p:nvSpPr>
        <p:spPr>
          <a:xfrm>
            <a:off x="2523234" y="4244395"/>
            <a:ext cx="2203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0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 photons m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6C3E1F8-8725-47F8-9C57-0A18801756F4}"/>
              </a:ext>
            </a:extLst>
          </p:cNvPr>
          <p:cNvSpPr txBox="1"/>
          <p:nvPr/>
        </p:nvSpPr>
        <p:spPr>
          <a:xfrm>
            <a:off x="2635659" y="5971919"/>
            <a:ext cx="19782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 photons m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BAD70F7-412C-07EB-3B91-D26511565D04}"/>
              </a:ext>
            </a:extLst>
          </p:cNvPr>
          <p:cNvSpPr/>
          <p:nvPr/>
        </p:nvSpPr>
        <p:spPr>
          <a:xfrm>
            <a:off x="1083439" y="300954"/>
            <a:ext cx="15522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chemeClr val="accent1"/>
                </a:solidFill>
              </a:rPr>
              <a:t>LL-</a:t>
            </a:r>
            <a:r>
              <a:rPr lang="en-US" dirty="0"/>
              <a:t>grown cells</a:t>
            </a:r>
            <a:endParaRPr lang="en-IL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C1175D4-9D90-7148-64B0-ED0F8F69FA47}"/>
              </a:ext>
            </a:extLst>
          </p:cNvPr>
          <p:cNvSpPr/>
          <p:nvPr/>
        </p:nvSpPr>
        <p:spPr>
          <a:xfrm>
            <a:off x="1632957" y="6030961"/>
            <a:ext cx="33534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chemeClr val="accent1"/>
                </a:solidFill>
              </a:rPr>
              <a:t>LL</a:t>
            </a:r>
            <a:endParaRPr lang="en-IL" sz="1400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2504D77-BE9F-BFD2-B966-AF6D647DE426}"/>
              </a:ext>
            </a:extLst>
          </p:cNvPr>
          <p:cNvSpPr/>
          <p:nvPr/>
        </p:nvSpPr>
        <p:spPr>
          <a:xfrm>
            <a:off x="1651696" y="4268922"/>
            <a:ext cx="33534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chemeClr val="accent1"/>
                </a:solidFill>
              </a:rPr>
              <a:t>LL</a:t>
            </a:r>
            <a:endParaRPr lang="en-IL" sz="14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9FE484F-694B-E01E-D4F6-2BCEFC32791C}"/>
              </a:ext>
            </a:extLst>
          </p:cNvPr>
          <p:cNvSpPr/>
          <p:nvPr/>
        </p:nvSpPr>
        <p:spPr>
          <a:xfrm>
            <a:off x="1658161" y="2479027"/>
            <a:ext cx="33534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chemeClr val="accent1"/>
                </a:solidFill>
              </a:rPr>
              <a:t>LL</a:t>
            </a:r>
            <a:endParaRPr lang="en-IL" sz="1400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926240E-EF46-903C-DCDB-53743B3986EB}"/>
              </a:ext>
            </a:extLst>
          </p:cNvPr>
          <p:cNvSpPr/>
          <p:nvPr/>
        </p:nvSpPr>
        <p:spPr>
          <a:xfrm>
            <a:off x="4725032" y="5995193"/>
            <a:ext cx="3722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chemeClr val="accent2"/>
                </a:solidFill>
              </a:rPr>
              <a:t>HL</a:t>
            </a:r>
            <a:endParaRPr lang="en-IL" sz="1400" dirty="0">
              <a:solidFill>
                <a:schemeClr val="accent2"/>
              </a:solidFill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D86C297-F7F7-B2C0-70FA-3902052992A7}"/>
              </a:ext>
            </a:extLst>
          </p:cNvPr>
          <p:cNvSpPr/>
          <p:nvPr/>
        </p:nvSpPr>
        <p:spPr>
          <a:xfrm>
            <a:off x="4617487" y="2479027"/>
            <a:ext cx="3722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chemeClr val="accent2"/>
                </a:solidFill>
              </a:rPr>
              <a:t>HL</a:t>
            </a:r>
            <a:endParaRPr lang="en-IL" sz="1400" dirty="0">
              <a:solidFill>
                <a:schemeClr val="accent2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5C3AF4D-E29F-020D-8ADB-458F0DD9283D}"/>
              </a:ext>
            </a:extLst>
          </p:cNvPr>
          <p:cNvSpPr/>
          <p:nvPr/>
        </p:nvSpPr>
        <p:spPr>
          <a:xfrm>
            <a:off x="4685918" y="4211877"/>
            <a:ext cx="3722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chemeClr val="accent2"/>
                </a:solidFill>
              </a:rPr>
              <a:t>HL</a:t>
            </a:r>
            <a:endParaRPr lang="en-IL" sz="1400" dirty="0">
              <a:solidFill>
                <a:schemeClr val="accent2"/>
              </a:solidFill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A428187-B19C-4B5C-B0AF-0DB49A268BF2}"/>
              </a:ext>
            </a:extLst>
          </p:cNvPr>
          <p:cNvSpPr/>
          <p:nvPr/>
        </p:nvSpPr>
        <p:spPr>
          <a:xfrm>
            <a:off x="500257" y="7754739"/>
            <a:ext cx="5833110" cy="13748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kern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2. </a:t>
            </a:r>
            <a:r>
              <a:rPr lang="en-US" sz="1100" i="1" kern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lorella ohadii </a:t>
            </a:r>
            <a:r>
              <a:rPr lang="en-US" sz="1100" kern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cks NPQ under low or high light intensities.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kern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luorescence traces of dark-adapted low and high light (LL, left, and HL, right)-grown cells. The fluorescence measurement was carried out under different light intensities, as indicated in the Methods section. Low NPQ was detected as indicated by the little change in F</a:t>
            </a:r>
            <a:r>
              <a:rPr lang="en-US" sz="1100" kern="1200" baseline="-250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lang="en-US" sz="1100" kern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’</a:t>
            </a:r>
            <a:r>
              <a:rPr lang="en-US" sz="1100" kern="1200" baseline="-250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kern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response to exposure to low or high light.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he graphs are representative of at least 3 biological repeats.</a:t>
            </a:r>
            <a:endParaRPr lang="en-IL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2036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3</TotalTime>
  <Words>118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di Schuster Lab</dc:creator>
  <cp:lastModifiedBy>Gadi Schuster Lab</cp:lastModifiedBy>
  <cp:revision>12</cp:revision>
  <dcterms:created xsi:type="dcterms:W3CDTF">2024-05-03T07:50:48Z</dcterms:created>
  <dcterms:modified xsi:type="dcterms:W3CDTF">2024-09-19T19:51:15Z</dcterms:modified>
</cp:coreProperties>
</file>